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1037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88870A-ACD4-47CD-8313-254ABD010696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16E0C9-124A-4CC5-9AC8-F43E5680D4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205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16E0C9-124A-4CC5-9AC8-F43E5680D49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60838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0789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2312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2383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0746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7685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5140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9167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468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5388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5461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2383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AFF487-B4C3-4BF4-B0F1-9BB8D1B8812D}" type="datetimeFigureOut">
              <a:rPr lang="en-GB" smtClean="0"/>
              <a:t>07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0A07AF-4181-461D-8561-8FE785DCEE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6178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20800" y="635000"/>
            <a:ext cx="25273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 smtClean="0"/>
              <a:t>463 patients enrolled</a:t>
            </a:r>
            <a:endParaRPr lang="en-GB" b="1" dirty="0"/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2442575" y="1039659"/>
            <a:ext cx="2238" cy="9895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2584450" y="1540701"/>
            <a:ext cx="2137862" cy="51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5035464" y="1252602"/>
            <a:ext cx="3206662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 smtClean="0"/>
              <a:t>Discontinued  (n=13)</a:t>
            </a:r>
          </a:p>
          <a:p>
            <a:r>
              <a:rPr lang="en-GB" dirty="0" smtClean="0"/>
              <a:t>Failed to answer the food frequency questionnaire</a:t>
            </a:r>
          </a:p>
          <a:p>
            <a:r>
              <a:rPr lang="en-GB" dirty="0" smtClean="0"/>
              <a:t>(FFQ)</a:t>
            </a:r>
            <a:endParaRPr lang="en-GB" dirty="0"/>
          </a:p>
        </p:txBody>
      </p:sp>
      <p:sp>
        <p:nvSpPr>
          <p:cNvPr id="11" name="Rectangle 10"/>
          <p:cNvSpPr/>
          <p:nvPr/>
        </p:nvSpPr>
        <p:spPr>
          <a:xfrm>
            <a:off x="1384734" y="2049767"/>
            <a:ext cx="2463366" cy="36933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GB" b="1" dirty="0" smtClean="0"/>
              <a:t>450 eligible patients </a:t>
            </a:r>
            <a:endParaRPr lang="en-GB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2442902" y="2451654"/>
            <a:ext cx="12199" cy="14629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V="1">
            <a:off x="2616417" y="3306871"/>
            <a:ext cx="2105895" cy="125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035463" y="2952465"/>
            <a:ext cx="3206662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 smtClean="0"/>
              <a:t>Excluded (n=2)</a:t>
            </a:r>
          </a:p>
          <a:p>
            <a:r>
              <a:rPr lang="en-GB" dirty="0" smtClean="0"/>
              <a:t>Failed to amplify the genotype</a:t>
            </a:r>
          </a:p>
          <a:p>
            <a:endParaRPr lang="en-GB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1384734" y="4051948"/>
            <a:ext cx="246762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 smtClean="0"/>
              <a:t>448 eligible patients </a:t>
            </a:r>
            <a:endParaRPr lang="en-GB" dirty="0"/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2442575" y="4546948"/>
            <a:ext cx="0" cy="13277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2584450" y="5054252"/>
            <a:ext cx="213786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5035464" y="4935255"/>
            <a:ext cx="320666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 smtClean="0"/>
              <a:t>Excluded (n=20)</a:t>
            </a:r>
          </a:p>
          <a:p>
            <a:r>
              <a:rPr lang="en-US" dirty="0" smtClean="0"/>
              <a:t>Missing data</a:t>
            </a:r>
            <a:endParaRPr lang="en-GB" dirty="0" smtClean="0"/>
          </a:p>
        </p:txBody>
      </p:sp>
      <p:sp>
        <p:nvSpPr>
          <p:cNvPr id="40" name="TextBox 39"/>
          <p:cNvSpPr txBox="1"/>
          <p:nvPr/>
        </p:nvSpPr>
        <p:spPr>
          <a:xfrm>
            <a:off x="1217318" y="5988257"/>
            <a:ext cx="246336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 smtClean="0"/>
              <a:t>Included in the analysis</a:t>
            </a:r>
          </a:p>
          <a:p>
            <a:pPr algn="ctr"/>
            <a:r>
              <a:rPr lang="en-GB" b="1" dirty="0" smtClean="0"/>
              <a:t> (n=428)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223711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47</Words>
  <Application>Microsoft Office PowerPoint</Application>
  <PresentationFormat>Widescreen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0</cp:revision>
  <dcterms:created xsi:type="dcterms:W3CDTF">2022-12-07T12:00:56Z</dcterms:created>
  <dcterms:modified xsi:type="dcterms:W3CDTF">2022-12-07T13:37:28Z</dcterms:modified>
</cp:coreProperties>
</file>